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959225" cy="7920038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EB4FA-6B82-4D0B-9AFF-7638F29A65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22360" y="2044440"/>
            <a:ext cx="291456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22360" y="4224240"/>
            <a:ext cx="291456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ECE0C8-86E3-48F9-86EB-E2F270DAB6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22360" y="20444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016000" y="20444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22360" y="42242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016000" y="42242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39813-1555-421E-A5D9-2AA4E3DFF8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22360" y="2044440"/>
            <a:ext cx="93816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 fontScale="84000"/>
          </a:bodyPr>
          <a:p>
            <a:pPr marL="28800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07680" y="2044440"/>
            <a:ext cx="93816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 fontScale="84000"/>
          </a:bodyPr>
          <a:p>
            <a:pPr marL="28800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493360" y="2044440"/>
            <a:ext cx="93816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 fontScale="84000"/>
          </a:bodyPr>
          <a:p>
            <a:pPr marL="28800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22360" y="4224240"/>
            <a:ext cx="93816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 fontScale="84000"/>
          </a:bodyPr>
          <a:p>
            <a:pPr marL="28800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07680" y="4224240"/>
            <a:ext cx="93816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 fontScale="84000"/>
          </a:bodyPr>
          <a:p>
            <a:pPr marL="28800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493360" y="4224240"/>
            <a:ext cx="93816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 fontScale="84000"/>
          </a:bodyPr>
          <a:p>
            <a:pPr marL="28800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7EC057-9170-469F-83D8-CF2A398CE7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22360" y="2044440"/>
            <a:ext cx="2914560" cy="417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CFE610-E6E9-468A-97D0-CE777231A7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22360" y="2044440"/>
            <a:ext cx="2914560" cy="417348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2349B-ED2E-4826-B665-C1EC4C4065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22360" y="2044440"/>
            <a:ext cx="1422000" cy="417348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016000" y="2044440"/>
            <a:ext cx="1422000" cy="417348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D6C22-9E4F-4D7D-9B1C-CED8F49C22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BAB776-5BFC-46F8-B0D1-569ADC563B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22360" y="647640"/>
            <a:ext cx="2914560" cy="556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8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916FC-BCB8-4698-ADE1-EDAF99AAAA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22360" y="20444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016000" y="2044440"/>
            <a:ext cx="1422000" cy="417348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22360" y="42242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AF6E0-4A58-409D-B440-7DAF3BD102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22360" y="2044440"/>
            <a:ext cx="1422000" cy="417348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016000" y="20444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016000" y="42242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544EC-CE64-49CD-BA0E-DF7CB02F2E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22360" y="620640"/>
            <a:ext cx="2914560" cy="12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22360" y="20444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016000" y="2044440"/>
            <a:ext cx="142200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22360" y="4224240"/>
            <a:ext cx="2914560" cy="199044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/>
          </a:bodyPr>
          <a:p>
            <a:pPr marL="343080" indent="0">
              <a:lnSpc>
                <a:spcPct val="98000"/>
              </a:lnSpc>
              <a:spcAft>
                <a:spcPts val="1349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098043-E81C-4507-BB72-2837E266A9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22360" y="647640"/>
            <a:ext cx="2914560" cy="1200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DejaVu Sans"/>
              </a:rPr>
              <a:t>Click to edit the title text format</a:t>
            </a:r>
            <a:endParaRPr b="0" lang="en-US" sz="42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22360" y="2044440"/>
            <a:ext cx="2914560" cy="4173480"/>
          </a:xfrm>
          <a:prstGeom prst="rect">
            <a:avLst/>
          </a:prstGeom>
          <a:noFill/>
          <a:ln w="0">
            <a:noFill/>
          </a:ln>
        </p:spPr>
        <p:txBody>
          <a:bodyPr lIns="0" rIns="0" tIns="7920" bIns="0" anchor="t">
            <a:normAutofit fontScale="59000"/>
          </a:bodyPr>
          <a:p>
            <a:pPr marL="202320" indent="0">
              <a:lnSpc>
                <a:spcPct val="98000"/>
              </a:lnSpc>
              <a:spcAft>
                <a:spcPts val="1349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DejaVu Sans"/>
              </a:rPr>
              <a:t>Click to edit the outline text format</a:t>
            </a: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  <a:p>
            <a:pPr lvl="1" marL="202320" indent="-202320">
              <a:lnSpc>
                <a:spcPct val="98000"/>
              </a:lnSpc>
              <a:spcAft>
                <a:spcPts val="1349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DejaVu Sans"/>
              </a:rPr>
              <a:t>Second Outline Level</a:t>
            </a: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  <a:p>
            <a:pPr lvl="2" marL="202320" indent="-202320">
              <a:lnSpc>
                <a:spcPct val="98000"/>
              </a:lnSpc>
              <a:spcAft>
                <a:spcPts val="1349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DejaVu Sans"/>
              </a:rPr>
              <a:t>Third Outline Level</a:t>
            </a: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  <a:p>
            <a:pPr lvl="3" marL="202320" indent="-202320">
              <a:lnSpc>
                <a:spcPct val="98000"/>
              </a:lnSpc>
              <a:spcAft>
                <a:spcPts val="1349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DejaVu Sans"/>
              </a:rPr>
              <a:t>Fourth Outline Level</a:t>
            </a: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  <a:p>
            <a:pPr lvl="4" marL="202320" indent="-202320">
              <a:lnSpc>
                <a:spcPct val="98000"/>
              </a:lnSpc>
              <a:spcAft>
                <a:spcPts val="1349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DejaVu Sans"/>
              </a:rPr>
              <a:t>Fifth Outline Level</a:t>
            </a: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  <a:p>
            <a:pPr lvl="5" marL="202320" indent="-202320">
              <a:lnSpc>
                <a:spcPct val="98000"/>
              </a:lnSpc>
              <a:spcAft>
                <a:spcPts val="1349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DejaVu Sans"/>
              </a:rPr>
              <a:t>Sixth Outline Level</a:t>
            </a: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  <a:p>
            <a:pPr lvl="6" marL="202320" indent="-202320">
              <a:lnSpc>
                <a:spcPct val="98000"/>
              </a:lnSpc>
              <a:spcAft>
                <a:spcPts val="1349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DejaVu Sans"/>
              </a:rPr>
              <a:t>Seventh Outline Level</a:t>
            </a:r>
            <a:endParaRPr b="0" lang="en-US" sz="31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22360" y="6919920"/>
            <a:ext cx="753840" cy="49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  <a:defRPr b="0" lang="it-IT" sz="1400" spc="-1" strike="noStrike">
                <a:solidFill>
                  <a:srgbClr val="000000"/>
                </a:solidFill>
                <a:latin typeface="DejaVu Serif"/>
                <a:ea typeface="DejaVu Sans"/>
              </a:defRPr>
            </a:lvl1pPr>
          </a:lstStyle>
          <a:p>
            <a:pPr indent="0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DejaVu Serif"/>
                <a:ea typeface="DejaVu Sans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68080" y="6919920"/>
            <a:ext cx="1025640" cy="49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</a:tabLst>
              <a:defRPr b="0" lang="it-IT" sz="1400" spc="-1" strike="noStrike">
                <a:solidFill>
                  <a:srgbClr val="000000"/>
                </a:solidFill>
                <a:latin typeface="DejaVu Serif"/>
                <a:ea typeface="DejaVu Sans"/>
              </a:defRPr>
            </a:lvl1pPr>
          </a:lstStyle>
          <a:p>
            <a:pPr indent="0" algn="ct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DejaVu Serif"/>
                <a:ea typeface="DejaVu Sans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682360" y="6919920"/>
            <a:ext cx="754200" cy="49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  <a:defRPr b="0" lang="it-IT" sz="1400" spc="-1" strike="noStrike">
                <a:solidFill>
                  <a:srgbClr val="000000"/>
                </a:solidFill>
                <a:latin typeface="DejaVu Serif"/>
                <a:ea typeface="DejaVu Sans"/>
              </a:defRPr>
            </a:lvl1pPr>
          </a:lstStyle>
          <a:p>
            <a:pPr indent="0" algn="r">
              <a:lnSpc>
                <a:spcPct val="98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fld id="{6307CC5F-C81F-4BC3-A6FD-A2F99C8616B3}" type="slidenum">
              <a:rPr b="0" lang="it-IT" sz="1400" spc="-1" strike="noStrike">
                <a:solidFill>
                  <a:srgbClr val="000000"/>
                </a:solidFill>
                <a:latin typeface="DejaVu Serif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DejaVu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60360" y="216000"/>
            <a:ext cx="3297240" cy="1042920"/>
          </a:xfrm>
          <a:prstGeom prst="rect">
            <a:avLst/>
          </a:prstGeom>
          <a:solidFill>
            <a:srgbClr val="729fcf"/>
          </a:solidFill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ctr">
            <a:noAutofit/>
          </a:bodyPr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Retrieval of </a:t>
            </a:r>
            <a:r>
              <a:rPr b="0" i="1" lang="it-IT" sz="1300" spc="-1" strike="noStrike">
                <a:solidFill>
                  <a:srgbClr val="000000"/>
                </a:solidFill>
                <a:latin typeface="Cantarell"/>
              </a:rPr>
              <a:t>Azospirillum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i="1" lang="it-IT" sz="1300" spc="-1" strike="noStrike">
                <a:solidFill>
                  <a:srgbClr val="000000"/>
                </a:solidFill>
                <a:latin typeface="Cantarell"/>
              </a:rPr>
              <a:t>brasilense </a:t>
            </a: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Sp245 chromosome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and plasmids sequences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2" name=""/>
          <p:cNvSpPr/>
          <p:nvPr/>
        </p:nvSpPr>
        <p:spPr>
          <a:xfrm>
            <a:off x="520560" y="1290600"/>
            <a:ext cx="425520" cy="1042920"/>
          </a:xfrm>
          <a:prstGeom prst="downArrow">
            <a:avLst>
              <a:gd name="adj1" fmla="val 50000"/>
              <a:gd name="adj2" fmla="val 61273"/>
            </a:avLst>
          </a:prstGeom>
          <a:solidFill>
            <a:srgbClr val="993366"/>
          </a:solidFill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8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3" name=""/>
          <p:cNvSpPr/>
          <p:nvPr/>
        </p:nvSpPr>
        <p:spPr>
          <a:xfrm>
            <a:off x="360360" y="2363760"/>
            <a:ext cx="3238560" cy="1042920"/>
          </a:xfrm>
          <a:prstGeom prst="rect">
            <a:avLst/>
          </a:prstGeom>
          <a:solidFill>
            <a:srgbClr val="ccff99"/>
          </a:solidFill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ctr">
            <a:noAutofit/>
          </a:bodyPr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List of connected proteins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(identity ≥ 40%, alignment ≥ 70%,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E-value &lt; 0.05) and of unconnected ones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4" name=""/>
          <p:cNvSpPr/>
          <p:nvPr/>
        </p:nvSpPr>
        <p:spPr>
          <a:xfrm>
            <a:off x="1063800" y="1440000"/>
            <a:ext cx="2246040" cy="191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Protein BLAST of all sequences against themselves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5" name=""/>
          <p:cNvSpPr/>
          <p:nvPr/>
        </p:nvSpPr>
        <p:spPr>
          <a:xfrm>
            <a:off x="520560" y="3438360"/>
            <a:ext cx="452520" cy="1043280"/>
          </a:xfrm>
          <a:prstGeom prst="downArrow">
            <a:avLst>
              <a:gd name="adj1" fmla="val 50000"/>
              <a:gd name="adj2" fmla="val 57637"/>
            </a:avLst>
          </a:prstGeom>
          <a:solidFill>
            <a:srgbClr val="993366"/>
          </a:solidFill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8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6" name=""/>
          <p:cNvSpPr/>
          <p:nvPr/>
        </p:nvSpPr>
        <p:spPr>
          <a:xfrm>
            <a:off x="360360" y="4513320"/>
            <a:ext cx="3238560" cy="1042920"/>
          </a:xfrm>
          <a:prstGeom prst="rect">
            <a:avLst/>
          </a:prstGeom>
          <a:solidFill>
            <a:srgbClr val="ff8080"/>
          </a:solidFill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ctr">
            <a:noAutofit/>
          </a:bodyPr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Protein functions and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organisms sharing the most similar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protein (POS, Preferential Organismal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Sharing)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7" name=""/>
          <p:cNvSpPr/>
          <p:nvPr/>
        </p:nvSpPr>
        <p:spPr>
          <a:xfrm>
            <a:off x="1096920" y="3774960"/>
            <a:ext cx="2386080" cy="60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BLAST2GO analysis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8" name=""/>
          <p:cNvSpPr/>
          <p:nvPr/>
        </p:nvSpPr>
        <p:spPr>
          <a:xfrm>
            <a:off x="520560" y="5586480"/>
            <a:ext cx="514440" cy="1042920"/>
          </a:xfrm>
          <a:prstGeom prst="downArrow">
            <a:avLst>
              <a:gd name="adj1" fmla="val 50000"/>
              <a:gd name="adj2" fmla="val 50682"/>
            </a:avLst>
          </a:prstGeom>
          <a:solidFill>
            <a:srgbClr val="993366"/>
          </a:solidFill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8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49" name=""/>
          <p:cNvSpPr/>
          <p:nvPr/>
        </p:nvSpPr>
        <p:spPr>
          <a:xfrm>
            <a:off x="360360" y="6661080"/>
            <a:ext cx="3238560" cy="1042920"/>
          </a:xfrm>
          <a:prstGeom prst="rect">
            <a:avLst/>
          </a:prstGeom>
          <a:solidFill>
            <a:srgbClr val="ff950e"/>
          </a:solidFill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ctr">
            <a:noAutofit/>
          </a:bodyPr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Proteins classified according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  <a:p>
            <a:pPr algn="ctr"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to the orthologous groups</a:t>
            </a:r>
            <a:r>
              <a:rPr b="0" lang="it-IT" sz="1400" spc="-1" strike="noStrike">
                <a:solidFill>
                  <a:srgbClr val="000000"/>
                </a:solidFill>
                <a:latin typeface="DejaVu Sans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DejaVu Sans"/>
            </a:endParaRPr>
          </a:p>
        </p:txBody>
      </p:sp>
      <p:sp>
        <p:nvSpPr>
          <p:cNvPr id="50" name=""/>
          <p:cNvSpPr/>
          <p:nvPr/>
        </p:nvSpPr>
        <p:spPr>
          <a:xfrm>
            <a:off x="1176480" y="5924520"/>
            <a:ext cx="2711160" cy="11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1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it-IT" sz="1300" spc="-1" strike="noStrike">
                <a:solidFill>
                  <a:srgbClr val="000000"/>
                </a:solidFill>
                <a:latin typeface="Cantarell"/>
              </a:rPr>
              <a:t>COG database characterization</a:t>
            </a:r>
            <a:endParaRPr b="0" lang="en-US" sz="1300" spc="-1" strike="noStrike">
              <a:solidFill>
                <a:srgbClr val="000000"/>
              </a:solidFill>
              <a:latin typeface="DejaVu Sans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5T11:25:33Z</dcterms:created>
  <dc:creator/>
  <dc:description/>
  <dc:language>en-US</dc:language>
  <cp:lastModifiedBy/>
  <dcterms:modified xsi:type="dcterms:W3CDTF">2014-11-05T11:46:40Z</dcterms:modified>
  <cp:revision>4</cp:revision>
  <dc:subject/>
  <dc:title/>
</cp:coreProperties>
</file>